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5\paper\table\Tabl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6462175715157496E-2"/>
          <c:y val="6.0358705161854799E-2"/>
          <c:w val="0.61075371092206299"/>
          <c:h val="0.79554425488480596"/>
        </c:manualLayout>
      </c:layout>
      <c:lineChart>
        <c:grouping val="standard"/>
        <c:varyColors val="0"/>
        <c:ser>
          <c:idx val="0"/>
          <c:order val="0"/>
          <c:tx>
            <c:strRef>
              <c:f>hrp!$A$38</c:f>
              <c:strCache>
                <c:ptCount val="1"/>
                <c:pt idx="0">
                  <c:v>hpaB(Xoo0075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38:$H$38</c:f>
              <c:numCache>
                <c:formatCode>General</c:formatCode>
                <c:ptCount val="7"/>
                <c:pt idx="0">
                  <c:v>1</c:v>
                </c:pt>
                <c:pt idx="1">
                  <c:v>1.4336622807017541</c:v>
                </c:pt>
                <c:pt idx="2">
                  <c:v>1.8629385964912279</c:v>
                </c:pt>
                <c:pt idx="3">
                  <c:v>2.0372807017543861</c:v>
                </c:pt>
                <c:pt idx="4">
                  <c:v>1.8733552631578949</c:v>
                </c:pt>
                <c:pt idx="5">
                  <c:v>1.1951754385964919</c:v>
                </c:pt>
                <c:pt idx="6">
                  <c:v>1.0186403508771931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hrp!$A$39</c:f>
              <c:strCache>
                <c:ptCount val="1"/>
                <c:pt idx="0">
                  <c:v>hrpE(Xoo007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39:$H$39</c:f>
              <c:numCache>
                <c:formatCode>General</c:formatCode>
                <c:ptCount val="7"/>
                <c:pt idx="0">
                  <c:v>1</c:v>
                </c:pt>
                <c:pt idx="1">
                  <c:v>0.98084336634837799</c:v>
                </c:pt>
                <c:pt idx="2">
                  <c:v>1.149457327560643</c:v>
                </c:pt>
                <c:pt idx="3">
                  <c:v>1.7114643259593141</c:v>
                </c:pt>
                <c:pt idx="4">
                  <c:v>1.697882687859557</c:v>
                </c:pt>
                <c:pt idx="5">
                  <c:v>1.0068797817448549</c:v>
                </c:pt>
                <c:pt idx="6">
                  <c:v>0.84366289069450195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hrp!$A$40</c:f>
              <c:strCache>
                <c:ptCount val="1"/>
                <c:pt idx="0">
                  <c:v>hrpD6(Xoo0077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40:$H$40</c:f>
              <c:numCache>
                <c:formatCode>General</c:formatCode>
                <c:ptCount val="7"/>
                <c:pt idx="0">
                  <c:v>1</c:v>
                </c:pt>
                <c:pt idx="1">
                  <c:v>1.743259085580305</c:v>
                </c:pt>
                <c:pt idx="2">
                  <c:v>2.3305978898007029</c:v>
                </c:pt>
                <c:pt idx="3">
                  <c:v>2.0164126611957789</c:v>
                </c:pt>
                <c:pt idx="4">
                  <c:v>2.1395076201641272</c:v>
                </c:pt>
                <c:pt idx="5">
                  <c:v>1.3587338804220399</c:v>
                </c:pt>
                <c:pt idx="6">
                  <c:v>0.63305978898006998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hrp!$A$41</c:f>
              <c:strCache>
                <c:ptCount val="1"/>
                <c:pt idx="0">
                  <c:v>hrpD5(Xoo0078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41:$H$41</c:f>
              <c:numCache>
                <c:formatCode>General</c:formatCode>
                <c:ptCount val="7"/>
                <c:pt idx="0">
                  <c:v>1</c:v>
                </c:pt>
                <c:pt idx="1">
                  <c:v>2.8977176669484361</c:v>
                </c:pt>
                <c:pt idx="2">
                  <c:v>2.895181741335588</c:v>
                </c:pt>
                <c:pt idx="3">
                  <c:v>2.4945054945054941</c:v>
                </c:pt>
                <c:pt idx="4">
                  <c:v>1.6086221470836859</c:v>
                </c:pt>
                <c:pt idx="5">
                  <c:v>0.98140321217244297</c:v>
                </c:pt>
                <c:pt idx="6">
                  <c:v>1.2738799661876581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hrp!$A$57</c:f>
              <c:strCache>
                <c:ptCount val="1"/>
                <c:pt idx="0">
                  <c:v>hpa1(Xoo0095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"/>
            </a:ln>
          </c:spPr>
          <c:marker>
            <c:symbol val="diamond"/>
            <c:size val="7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57:$H$57</c:f>
              <c:numCache>
                <c:formatCode>General</c:formatCode>
                <c:ptCount val="7"/>
                <c:pt idx="0">
                  <c:v>1</c:v>
                </c:pt>
                <c:pt idx="1">
                  <c:v>1.4172709294660519</c:v>
                </c:pt>
                <c:pt idx="2">
                  <c:v>1.72972972972973</c:v>
                </c:pt>
                <c:pt idx="3">
                  <c:v>2.6090969017798291</c:v>
                </c:pt>
                <c:pt idx="4">
                  <c:v>3.6005273566249181</c:v>
                </c:pt>
                <c:pt idx="5">
                  <c:v>2.9802241265655902</c:v>
                </c:pt>
                <c:pt idx="6">
                  <c:v>1.373764007910349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hrp!$A$58</c:f>
              <c:strCache>
                <c:ptCount val="1"/>
                <c:pt idx="0">
                  <c:v>hpa2(Xoo009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Dot"/>
            </a:ln>
          </c:spPr>
          <c:marker>
            <c:symbol val="diamond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58:$H$58</c:f>
              <c:numCache>
                <c:formatCode>General</c:formatCode>
                <c:ptCount val="7"/>
                <c:pt idx="0">
                  <c:v>1</c:v>
                </c:pt>
                <c:pt idx="1">
                  <c:v>2.2155797101449282</c:v>
                </c:pt>
                <c:pt idx="2">
                  <c:v>3.25</c:v>
                </c:pt>
                <c:pt idx="3">
                  <c:v>3.8731884057971011</c:v>
                </c:pt>
                <c:pt idx="4">
                  <c:v>3.2971014492753632</c:v>
                </c:pt>
                <c:pt idx="5">
                  <c:v>1.2844202898550721</c:v>
                </c:pt>
                <c:pt idx="6">
                  <c:v>1.639492753623188</c:v>
                </c:pt>
              </c:numCache>
            </c:numRef>
          </c:val>
          <c:smooth val="1"/>
        </c:ser>
        <c:ser>
          <c:idx val="6"/>
          <c:order val="6"/>
          <c:tx>
            <c:strRef>
              <c:f>hrp!$A$166</c:f>
              <c:strCache>
                <c:ptCount val="1"/>
                <c:pt idx="0">
                  <c:v>hpaB(Xoo0075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66:$H$166</c:f>
              <c:numCache>
                <c:formatCode>General</c:formatCode>
                <c:ptCount val="7"/>
                <c:pt idx="0">
                  <c:v>1</c:v>
                </c:pt>
                <c:pt idx="1">
                  <c:v>1.126628075253256</c:v>
                </c:pt>
                <c:pt idx="2">
                  <c:v>0.96526772793053495</c:v>
                </c:pt>
                <c:pt idx="3">
                  <c:v>1.1751085383502169</c:v>
                </c:pt>
                <c:pt idx="4">
                  <c:v>1.323444283646888</c:v>
                </c:pt>
                <c:pt idx="5">
                  <c:v>0.90955137481910298</c:v>
                </c:pt>
                <c:pt idx="6">
                  <c:v>1.003617945007236</c:v>
                </c:pt>
              </c:numCache>
            </c:numRef>
          </c:val>
          <c:smooth val="1"/>
        </c:ser>
        <c:ser>
          <c:idx val="7"/>
          <c:order val="7"/>
          <c:tx>
            <c:strRef>
              <c:f>hrp!$A$167</c:f>
              <c:strCache>
                <c:ptCount val="1"/>
                <c:pt idx="0">
                  <c:v>hrpE(Xoo007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ys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67:$H$167</c:f>
              <c:numCache>
                <c:formatCode>General</c:formatCode>
                <c:ptCount val="7"/>
                <c:pt idx="0">
                  <c:v>1</c:v>
                </c:pt>
                <c:pt idx="1">
                  <c:v>1.1288964976103859</c:v>
                </c:pt>
                <c:pt idx="2">
                  <c:v>1.075825665168699</c:v>
                </c:pt>
                <c:pt idx="3">
                  <c:v>1.362365361295385</c:v>
                </c:pt>
                <c:pt idx="4">
                  <c:v>1.319280975818532</c:v>
                </c:pt>
                <c:pt idx="5">
                  <c:v>1.193665739353734</c:v>
                </c:pt>
                <c:pt idx="6">
                  <c:v>1.190955132320423</c:v>
                </c:pt>
              </c:numCache>
            </c:numRef>
          </c:val>
          <c:smooth val="1"/>
        </c:ser>
        <c:ser>
          <c:idx val="8"/>
          <c:order val="8"/>
          <c:tx>
            <c:strRef>
              <c:f>hrp!$A$168</c:f>
              <c:strCache>
                <c:ptCount val="1"/>
                <c:pt idx="0">
                  <c:v>hrpD6(Xoo0077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68:$H$168</c:f>
              <c:numCache>
                <c:formatCode>General</c:formatCode>
                <c:ptCount val="7"/>
                <c:pt idx="0">
                  <c:v>1</c:v>
                </c:pt>
                <c:pt idx="1">
                  <c:v>1.39511201629328</c:v>
                </c:pt>
                <c:pt idx="2">
                  <c:v>0.98031228784792901</c:v>
                </c:pt>
                <c:pt idx="3">
                  <c:v>1.3964697895451459</c:v>
                </c:pt>
                <c:pt idx="4">
                  <c:v>1.5437881873727091</c:v>
                </c:pt>
                <c:pt idx="5">
                  <c:v>1.179226069246436</c:v>
                </c:pt>
                <c:pt idx="6">
                  <c:v>1.064494229463679</c:v>
                </c:pt>
              </c:numCache>
            </c:numRef>
          </c:val>
          <c:smooth val="1"/>
        </c:ser>
        <c:ser>
          <c:idx val="9"/>
          <c:order val="9"/>
          <c:tx>
            <c:strRef>
              <c:f>hrp!$A$169</c:f>
              <c:strCache>
                <c:ptCount val="1"/>
                <c:pt idx="0">
                  <c:v>hrpD5(Xoo0078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69:$H$169</c:f>
              <c:numCache>
                <c:formatCode>General</c:formatCode>
                <c:ptCount val="7"/>
                <c:pt idx="0">
                  <c:v>1</c:v>
                </c:pt>
                <c:pt idx="1">
                  <c:v>0.969887076537014</c:v>
                </c:pt>
                <c:pt idx="2">
                  <c:v>0.90840652446674997</c:v>
                </c:pt>
                <c:pt idx="3">
                  <c:v>1.1656210790464241</c:v>
                </c:pt>
                <c:pt idx="4">
                  <c:v>1.2452948557089081</c:v>
                </c:pt>
                <c:pt idx="5">
                  <c:v>1.1499372647427859</c:v>
                </c:pt>
                <c:pt idx="6">
                  <c:v>1.0181932245922209</c:v>
                </c:pt>
              </c:numCache>
            </c:numRef>
          </c:val>
          <c:smooth val="1"/>
        </c:ser>
        <c:ser>
          <c:idx val="10"/>
          <c:order val="10"/>
          <c:tx>
            <c:strRef>
              <c:f>hrp!$A$170</c:f>
              <c:strCache>
                <c:ptCount val="1"/>
                <c:pt idx="0">
                  <c:v>hpa1(Xoo0095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ymbol val="diamond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70:$H$170</c:f>
              <c:numCache>
                <c:formatCode>General</c:formatCode>
                <c:ptCount val="7"/>
                <c:pt idx="0">
                  <c:v>1</c:v>
                </c:pt>
                <c:pt idx="1">
                  <c:v>1.096417281348788</c:v>
                </c:pt>
                <c:pt idx="2">
                  <c:v>0.9536354056902</c:v>
                </c:pt>
                <c:pt idx="3">
                  <c:v>1.292413066385669</c:v>
                </c:pt>
                <c:pt idx="4">
                  <c:v>1.092202318229716</c:v>
                </c:pt>
                <c:pt idx="5">
                  <c:v>0.94204425711274997</c:v>
                </c:pt>
                <c:pt idx="6">
                  <c:v>1.126448893572181</c:v>
                </c:pt>
              </c:numCache>
            </c:numRef>
          </c:val>
          <c:smooth val="1"/>
        </c:ser>
        <c:ser>
          <c:idx val="11"/>
          <c:order val="11"/>
          <c:tx>
            <c:strRef>
              <c:f>hrp!$A$171</c:f>
              <c:strCache>
                <c:ptCount val="1"/>
                <c:pt idx="0">
                  <c:v>hpa2(Xoo009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Dot"/>
            </a:ln>
          </c:spPr>
          <c:marker>
            <c:symbol val="diamond"/>
            <c:size val="5"/>
            <c:spPr>
              <a:noFill/>
              <a:ln w="9525">
                <a:solidFill>
                  <a:srgbClr val="FF0000"/>
                </a:solidFill>
                <a:prstDash val="solid"/>
              </a:ln>
            </c:spPr>
          </c:marker>
          <c:cat>
            <c:numRef>
              <c:f>hrp!$B$30:$H$30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hrp!$B$171:$H$171</c:f>
              <c:numCache>
                <c:formatCode>General</c:formatCode>
                <c:ptCount val="7"/>
                <c:pt idx="0">
                  <c:v>1</c:v>
                </c:pt>
                <c:pt idx="1">
                  <c:v>0.75985663082437305</c:v>
                </c:pt>
                <c:pt idx="2">
                  <c:v>0.92831541218638003</c:v>
                </c:pt>
                <c:pt idx="3">
                  <c:v>1.2532855436081241</c:v>
                </c:pt>
                <c:pt idx="4">
                  <c:v>0.87335722819593797</c:v>
                </c:pt>
                <c:pt idx="5">
                  <c:v>0.812425328554361</c:v>
                </c:pt>
                <c:pt idx="6">
                  <c:v>0.80764635603345303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5296256"/>
        <c:axId val="65306624"/>
      </c:lineChart>
      <c:catAx>
        <c:axId val="65296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5306624"/>
        <c:crosses val="autoZero"/>
        <c:auto val="1"/>
        <c:lblAlgn val="ctr"/>
        <c:lblOffset val="100"/>
        <c:noMultiLvlLbl val="0"/>
      </c:catAx>
      <c:valAx>
        <c:axId val="65306624"/>
        <c:scaling>
          <c:orientation val="minMax"/>
          <c:max val="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65296256"/>
        <c:crosses val="autoZero"/>
        <c:crossBetween val="between"/>
        <c:majorUnit val="2.5"/>
      </c:valAx>
    </c:plotArea>
    <c:legend>
      <c:legendPos val="r"/>
      <c:legendEntry>
        <c:idx val="0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egendEntry>
        <c:idx val="2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egendEntry>
        <c:idx val="3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egendEntry>
        <c:idx val="4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egendEntry>
        <c:idx val="5"/>
        <c:txPr>
          <a:bodyPr/>
          <a:lstStyle/>
          <a:p>
            <a:pPr>
              <a:defRPr sz="800" i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</c:legendEntry>
      <c:layout>
        <c:manualLayout>
          <c:xMode val="edge"/>
          <c:yMode val="edge"/>
          <c:x val="0.69693183857323704"/>
          <c:y val="2.34835228929717E-2"/>
          <c:w val="0.27129291954136803"/>
          <c:h val="0.938907997222591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/>
          <p:cNvGrpSpPr/>
          <p:nvPr/>
        </p:nvGrpSpPr>
        <p:grpSpPr>
          <a:xfrm>
            <a:off x="1052235" y="1790575"/>
            <a:ext cx="6077885" cy="2876655"/>
            <a:chOff x="789689" y="2132856"/>
            <a:chExt cx="6077885" cy="2876655"/>
          </a:xfrm>
        </p:grpSpPr>
        <p:graphicFrame>
          <p:nvGraphicFramePr>
            <p:cNvPr id="8" name="차트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39185438"/>
                </p:ext>
              </p:extLst>
            </p:nvPr>
          </p:nvGraphicFramePr>
          <p:xfrm>
            <a:off x="971600" y="2132856"/>
            <a:ext cx="5895974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 rot="16200000">
              <a:off x="423402" y="3149010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946503" y="4747901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2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017268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0</TotalTime>
  <Words>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4</cp:revision>
  <dcterms:created xsi:type="dcterms:W3CDTF">2016-01-26T07:31:38Z</dcterms:created>
  <dcterms:modified xsi:type="dcterms:W3CDTF">2016-04-28T09:52:30Z</dcterms:modified>
</cp:coreProperties>
</file>